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56" r:id="rId4"/>
    <p:sldId id="257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65" autoAdjust="0"/>
  </p:normalViewPr>
  <p:slideViewPr>
    <p:cSldViewPr snapToGrid="0">
      <p:cViewPr varScale="1">
        <p:scale>
          <a:sx n="103" d="100"/>
          <a:sy n="103" d="100"/>
        </p:scale>
        <p:origin x="7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930D3D-CFFC-4E7B-889A-F00DF6DD79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4DF509F-057D-4DEF-AD4A-DF9E5E4368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8FD758-4D4E-44F6-819D-73F3C14E64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6C0095-CFCE-48E6-B84C-A7E323791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50C792-62F2-4C11-8A7A-09A11F1DC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0471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103251-4BF2-4E66-92F3-77FBB78C10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CDED9F-FFCB-4096-9B07-F531FF78A9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AB83EA-7E01-40AA-A93C-D7FB74D0C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7F613FC-CF9D-4A2D-B968-FFC2E88EA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E568B8-5B6F-48F4-9959-7A288C707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3364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2E317B0-BE2A-4BEE-94B8-72F4F426A8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DA48AF2-F6A9-4C2B-B58A-E3D418F1CF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909F17-36A1-49FA-9EB7-0DEC081D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B6BCD6-E1F4-476A-89DF-64F9328F8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9951CF-FB91-43BC-89E8-EC427921D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0296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F9E975-B7C3-47C9-BCA3-2A56BBC818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96B5686-382B-48F7-8018-B5E87216B4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D652C4-3033-498C-A3BC-396DD40A0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FEF3952-9F2E-42E5-AE36-FD742804D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0A07BD-9316-40C5-8075-CBD8E7C593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823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A1B15F-8369-444B-A8F2-8AF33BC129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83B565-EEBB-4DB1-9079-0B48638B35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FB5493-6C5F-4879-8D94-BB737F85B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F4251C-3179-4FEF-8878-2DEF01BCC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627E4E-EC3F-4D63-96B8-54E16FC28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651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F1A5F7-45B1-46C6-AC7D-DD26B5822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6904433-C387-4B8E-94F5-BB7215A1D8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40E1312-77DB-4B63-9455-0C0B85B41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D163C69-A42A-4546-AE76-6B54BA7CF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7DCBD07-EA95-4B49-85E2-0D1B8D37A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23268B7-BA12-45CF-83BB-286543182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47940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5550B9-9091-4B4E-BBBE-8625316FE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D21396-2228-406C-B29E-6A5FECB1A2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740C07-ED60-40E0-83F2-F6AB98421D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57F8297-B533-4568-BFFA-3E1B9F1408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58F3EB7-3F2D-4873-AF7D-DF5D9041BB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61B69DE-9111-4AD9-967A-3DF51D7C8B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C2FFA7B-A8DB-4246-A548-D8DF8AB90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7BF71E3-F927-4A8A-9B96-F03FFA474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4175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BF1127-DCA2-4DBB-9C79-313FBC0E63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C4E63F6-0D0E-46D9-B553-ABDDFEC29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48DB003-FA92-4B29-85CC-09A82FC0F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1773BD8-5C39-4690-BDFF-677C1CA95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332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E1DA4FD-BFAE-4FEA-BD46-40EBB8EA3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5F5FA49-64A3-4430-B3C8-547AE2C03D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8404DF9-6D14-43F0-A2E0-643B834FD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806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D7F5E8-116D-45C7-890A-E6750F15D7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F656D80-BFB9-45E7-AEAA-66490520B1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975AB27-3CE4-48CD-B3E5-9F2B94975D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6D43D7-D254-4344-8D1E-426A31B07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539274-1926-4FF8-9883-479B9BCA8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B59C72-B553-429E-BFD9-CE3B21BB6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8797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086101-70ED-4EE1-8E3B-A74307482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DC2F211-6223-4098-AE36-4AB4B70935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1B9AFFA-4CFF-465B-B4FC-19A6F45983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C7700F-1A5F-431B-917C-B7A670FF2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F95BA6B-CA23-43F3-890C-2B57AD55E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06D8456-682B-479B-91DD-52B07345D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8112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676439A-C4B8-4F9B-85F0-392E02CFFD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7A6C69D-1DCB-46DF-BD71-B35699C98A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75A0F18-9DB3-40CF-8A29-D088469496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FA5A9-A4C1-4DF7-8F22-EDBEFCF607AE}" type="datetimeFigureOut">
              <a:rPr kumimoji="1" lang="ja-JP" altLang="en-US" smtClean="0"/>
              <a:t>2021/2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E47B2A-427A-4551-B124-7CDF59ECDC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8DF17F-6603-48D4-9CC9-09D4EEC391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13B16-C2A6-40FB-A3EE-A8CAC50F70E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883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F853F46-10B1-4DAC-BB98-6E67E1BA36E9}"/>
              </a:ext>
            </a:extLst>
          </p:cNvPr>
          <p:cNvSpPr/>
          <p:nvPr/>
        </p:nvSpPr>
        <p:spPr>
          <a:xfrm>
            <a:off x="411892" y="59967"/>
            <a:ext cx="1136821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1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lowchart of patient enrollments of the low grade endometrial stromal (LGESS) group and the rare leiomyoma variants group.</a:t>
            </a:r>
            <a:endParaRPr lang="ja-JP" altLang="en-US" dirty="0">
              <a:highlight>
                <a:srgbClr val="FFFF00"/>
              </a:highlight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C01E151-76E6-48C5-A6D8-06C8B86E5662}"/>
              </a:ext>
            </a:extLst>
          </p:cNvPr>
          <p:cNvSpPr txBox="1"/>
          <p:nvPr/>
        </p:nvSpPr>
        <p:spPr>
          <a:xfrm>
            <a:off x="411892" y="1613648"/>
            <a:ext cx="5146225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Patients with pathologically confirmed LGESS</a:t>
            </a:r>
          </a:p>
          <a:p>
            <a:r>
              <a:rPr lang="en-US" altLang="ja-JP" dirty="0"/>
              <a:t> - </a:t>
            </a:r>
            <a:r>
              <a:rPr kumimoji="1" lang="en-US" altLang="ja-JP" dirty="0"/>
              <a:t>N=28</a:t>
            </a:r>
          </a:p>
          <a:p>
            <a:r>
              <a:rPr lang="en-US" altLang="ja-JP" dirty="0"/>
              <a:t> - Seven institutions</a:t>
            </a:r>
          </a:p>
          <a:p>
            <a:r>
              <a:rPr lang="en-US" altLang="ja-JP" dirty="0"/>
              <a:t> - Between 2007 and 2018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751619D-CE42-4B0C-8AB8-5068EDE0A349}"/>
              </a:ext>
            </a:extLst>
          </p:cNvPr>
          <p:cNvSpPr txBox="1"/>
          <p:nvPr/>
        </p:nvSpPr>
        <p:spPr>
          <a:xfrm>
            <a:off x="5840189" y="1613648"/>
            <a:ext cx="5939920" cy="147732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Patients with pathologically confirmed rare leiomyoma variants</a:t>
            </a:r>
          </a:p>
          <a:p>
            <a:r>
              <a:rPr lang="en-US" altLang="ja-JP" dirty="0"/>
              <a:t> - N</a:t>
            </a:r>
            <a:r>
              <a:rPr kumimoji="1" lang="en-US" altLang="ja-JP" dirty="0"/>
              <a:t>=55</a:t>
            </a:r>
          </a:p>
          <a:p>
            <a:r>
              <a:rPr lang="en-US" altLang="ja-JP" dirty="0"/>
              <a:t> - Two institutions</a:t>
            </a:r>
          </a:p>
          <a:p>
            <a:r>
              <a:rPr lang="en-US" altLang="ja-JP" dirty="0"/>
              <a:t> - Between 2007 and 2018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AFCA07B-2E06-49BB-B76F-61F54AAE132B}"/>
              </a:ext>
            </a:extLst>
          </p:cNvPr>
          <p:cNvSpPr txBox="1"/>
          <p:nvPr/>
        </p:nvSpPr>
        <p:spPr>
          <a:xfrm>
            <a:off x="1210679" y="3569365"/>
            <a:ext cx="4351107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Excluded cases</a:t>
            </a:r>
          </a:p>
          <a:p>
            <a:pPr marL="285750" indent="-285750">
              <a:buFontTx/>
              <a:buChar char="-"/>
            </a:pPr>
            <a:r>
              <a:rPr lang="en-US" altLang="ja-JP" dirty="0"/>
              <a:t>Absent pretreatment MRI (N=2)</a:t>
            </a:r>
          </a:p>
          <a:p>
            <a:pPr marL="285750" indent="-285750">
              <a:buFontTx/>
              <a:buChar char="-"/>
            </a:pPr>
            <a:r>
              <a:rPr kumimoji="1" lang="en-US" altLang="ja-JP" dirty="0"/>
              <a:t>Absent pret</a:t>
            </a:r>
            <a:r>
              <a:rPr lang="en-US" altLang="ja-JP" dirty="0"/>
              <a:t>reatment MRI in DICOM format (N=1)</a:t>
            </a:r>
            <a:endParaRPr kumimoji="1" lang="en-US" altLang="ja-JP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1854D40-49B1-49ED-8DDE-2E67A928FCDF}"/>
              </a:ext>
            </a:extLst>
          </p:cNvPr>
          <p:cNvSpPr txBox="1"/>
          <p:nvPr/>
        </p:nvSpPr>
        <p:spPr>
          <a:xfrm>
            <a:off x="6672975" y="3441690"/>
            <a:ext cx="5107133" cy="203132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Excluded cases</a:t>
            </a:r>
          </a:p>
          <a:p>
            <a:pPr marL="285750" indent="-285750">
              <a:buFontTx/>
              <a:buChar char="-"/>
            </a:pPr>
            <a:r>
              <a:rPr lang="en-US" altLang="ja-JP" dirty="0"/>
              <a:t>Absent pretreatment MRI (N=9)</a:t>
            </a:r>
          </a:p>
          <a:p>
            <a:pPr marL="285750" indent="-285750">
              <a:buFontTx/>
              <a:buChar char="-"/>
            </a:pPr>
            <a:r>
              <a:rPr kumimoji="1" lang="en-US" altLang="ja-JP" dirty="0"/>
              <a:t>Difficulty in identification because of multiplicity of leiomyomas (N=2)</a:t>
            </a:r>
          </a:p>
          <a:p>
            <a:pPr marL="285750" indent="-285750">
              <a:buFontTx/>
              <a:buChar char="-"/>
            </a:pPr>
            <a:r>
              <a:rPr lang="en-US" altLang="ja-JP" dirty="0"/>
              <a:t>Remarkable degeneration because of red degeneration after pregnancy (N=1) or aborting leiomyoma (N=1)</a:t>
            </a:r>
            <a:endParaRPr kumimoji="1" lang="en-US" altLang="ja-JP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BD18C01-EAB5-4A9C-81E5-ECCD59E912A2}"/>
              </a:ext>
            </a:extLst>
          </p:cNvPr>
          <p:cNvSpPr txBox="1"/>
          <p:nvPr/>
        </p:nvSpPr>
        <p:spPr>
          <a:xfrm>
            <a:off x="407760" y="5809470"/>
            <a:ext cx="515402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The LGESS group (N=25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2467FA0-91DD-4EBB-A946-FB5B351119FB}"/>
              </a:ext>
            </a:extLst>
          </p:cNvPr>
          <p:cNvSpPr txBox="1"/>
          <p:nvPr/>
        </p:nvSpPr>
        <p:spPr>
          <a:xfrm>
            <a:off x="5840189" y="5809470"/>
            <a:ext cx="593991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The Rare leiomyoma variant group (N=42)</a:t>
            </a: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B5C35027-7580-48F3-8165-7AC16FBAEEC3}"/>
              </a:ext>
            </a:extLst>
          </p:cNvPr>
          <p:cNvCxnSpPr>
            <a:cxnSpLocks/>
          </p:cNvCxnSpPr>
          <p:nvPr/>
        </p:nvCxnSpPr>
        <p:spPr>
          <a:xfrm>
            <a:off x="630848" y="2813977"/>
            <a:ext cx="0" cy="2974981"/>
          </a:xfrm>
          <a:prstGeom prst="straightConnector1">
            <a:avLst/>
          </a:prstGeom>
          <a:ln w="476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98A31EE6-6122-4B87-83AF-501D544E3DDD}"/>
              </a:ext>
            </a:extLst>
          </p:cNvPr>
          <p:cNvCxnSpPr>
            <a:cxnSpLocks/>
          </p:cNvCxnSpPr>
          <p:nvPr/>
        </p:nvCxnSpPr>
        <p:spPr>
          <a:xfrm>
            <a:off x="630848" y="4232630"/>
            <a:ext cx="578904" cy="0"/>
          </a:xfrm>
          <a:prstGeom prst="straightConnector1">
            <a:avLst/>
          </a:prstGeom>
          <a:ln w="4762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8F06679A-AB27-47B2-950B-813A2F239053}"/>
              </a:ext>
            </a:extLst>
          </p:cNvPr>
          <p:cNvCxnSpPr>
            <a:cxnSpLocks/>
          </p:cNvCxnSpPr>
          <p:nvPr/>
        </p:nvCxnSpPr>
        <p:spPr>
          <a:xfrm>
            <a:off x="6096000" y="4267402"/>
            <a:ext cx="578904" cy="0"/>
          </a:xfrm>
          <a:prstGeom prst="straightConnector1">
            <a:avLst/>
          </a:prstGeom>
          <a:ln w="4762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BB990502-6B32-4AAC-AE1F-9EEE4FD309C9}"/>
              </a:ext>
            </a:extLst>
          </p:cNvPr>
          <p:cNvCxnSpPr>
            <a:cxnSpLocks/>
          </p:cNvCxnSpPr>
          <p:nvPr/>
        </p:nvCxnSpPr>
        <p:spPr>
          <a:xfrm>
            <a:off x="6096000" y="3090976"/>
            <a:ext cx="0" cy="2697982"/>
          </a:xfrm>
          <a:prstGeom prst="straightConnector1">
            <a:avLst/>
          </a:prstGeom>
          <a:ln w="476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2340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9CE8010-6195-4F80-8719-75758E4B7DD7}"/>
              </a:ext>
            </a:extLst>
          </p:cNvPr>
          <p:cNvSpPr/>
          <p:nvPr/>
        </p:nvSpPr>
        <p:spPr>
          <a:xfrm>
            <a:off x="411892" y="59967"/>
            <a:ext cx="1154062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2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other case of low grade endometrial stromal sarcoma with low signal intensity (SI) rim (A, arrow), intra-tumoral bands (A, arrowheads), and cystic/necrotic change on T2-weighted images. Intra-tumoral high SI (B, *) was observed on T1-weighted images with fat saturation, indicating tumoral hemorrhage. Remarkable heterogenous tumor enhancement was observed on contrast enhanced T1-weighted images (C). </a:t>
            </a:r>
            <a:endParaRPr lang="ja-JP" altLang="en-US" dirty="0">
              <a:highlight>
                <a:srgbClr val="FFFF00"/>
              </a:highlight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AF9D14D-1A0A-4109-BB60-E89AA32B6C98}"/>
              </a:ext>
            </a:extLst>
          </p:cNvPr>
          <p:cNvSpPr txBox="1"/>
          <p:nvPr/>
        </p:nvSpPr>
        <p:spPr>
          <a:xfrm>
            <a:off x="78146" y="2754973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5BE5F86-13D5-4F6E-8B79-2ED2316DF24F}"/>
              </a:ext>
            </a:extLst>
          </p:cNvPr>
          <p:cNvSpPr txBox="1"/>
          <p:nvPr/>
        </p:nvSpPr>
        <p:spPr>
          <a:xfrm>
            <a:off x="4075531" y="2754973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1C94896-BE4A-4222-AD7A-39629A3BC0E7}"/>
              </a:ext>
            </a:extLst>
          </p:cNvPr>
          <p:cNvSpPr txBox="1"/>
          <p:nvPr/>
        </p:nvSpPr>
        <p:spPr>
          <a:xfrm>
            <a:off x="8230335" y="2754973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pic>
        <p:nvPicPr>
          <p:cNvPr id="6" name="図 5" descr="座る, 写真, 古い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E9BE2F72-AF7E-4061-996A-951651AFD4C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80" t="21970" r="16773" b="25917"/>
          <a:stretch/>
        </p:blipFill>
        <p:spPr>
          <a:xfrm>
            <a:off x="4075531" y="3202482"/>
            <a:ext cx="4031972" cy="3225212"/>
          </a:xfrm>
          <a:prstGeom prst="rect">
            <a:avLst/>
          </a:prstGeom>
        </p:spPr>
      </p:pic>
      <p:pic>
        <p:nvPicPr>
          <p:cNvPr id="7" name="図 6" descr="屋内, 写真, 座る, ベッド が含まれている画像&#10;&#10;自動的に生成された説明">
            <a:extLst>
              <a:ext uri="{FF2B5EF4-FFF2-40B4-BE49-F238E27FC236}">
                <a16:creationId xmlns:a16="http://schemas.microsoft.com/office/drawing/2014/main" id="{75DEA0A4-8F2B-4CA0-B263-BC4FCA7EC23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20" t="21204" r="16534" b="26684"/>
          <a:stretch/>
        </p:blipFill>
        <p:spPr>
          <a:xfrm>
            <a:off x="24443" y="3202483"/>
            <a:ext cx="4031972" cy="3225211"/>
          </a:xfrm>
          <a:prstGeom prst="rect">
            <a:avLst/>
          </a:prstGeom>
        </p:spPr>
      </p:pic>
      <p:pic>
        <p:nvPicPr>
          <p:cNvPr id="8" name="図 7" descr="屋内, 座る, 写真, ベッド が含まれている画像&#10;&#10;自動的に生成された説明">
            <a:extLst>
              <a:ext uri="{FF2B5EF4-FFF2-40B4-BE49-F238E27FC236}">
                <a16:creationId xmlns:a16="http://schemas.microsoft.com/office/drawing/2014/main" id="{822A5CBE-E82C-41E4-A837-3C5E4672FA7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26" t="21332" r="17426" b="26557"/>
          <a:stretch/>
        </p:blipFill>
        <p:spPr>
          <a:xfrm>
            <a:off x="8126619" y="3202481"/>
            <a:ext cx="4031973" cy="3225213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0E5F133-793C-42EE-A651-C5EE8E296405}"/>
              </a:ext>
            </a:extLst>
          </p:cNvPr>
          <p:cNvSpPr txBox="1"/>
          <p:nvPr/>
        </p:nvSpPr>
        <p:spPr>
          <a:xfrm>
            <a:off x="5943266" y="5145541"/>
            <a:ext cx="51395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dirty="0">
                <a:solidFill>
                  <a:schemeClr val="bg1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</a:t>
            </a:r>
            <a:endParaRPr lang="ja-JP" altLang="en-US" sz="2400" dirty="0">
              <a:solidFill>
                <a:schemeClr val="bg1"/>
              </a:solidFill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01C251E-0C59-4923-8EA1-79605AFFD884}"/>
              </a:ext>
            </a:extLst>
          </p:cNvPr>
          <p:cNvSpPr txBox="1"/>
          <p:nvPr/>
        </p:nvSpPr>
        <p:spPr>
          <a:xfrm>
            <a:off x="5577565" y="4518012"/>
            <a:ext cx="51395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dirty="0">
                <a:solidFill>
                  <a:schemeClr val="bg1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</a:t>
            </a:r>
            <a:endParaRPr lang="ja-JP" altLang="en-US" sz="2400" dirty="0">
              <a:solidFill>
                <a:schemeClr val="bg1"/>
              </a:solidFill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4090C749-8FC2-462D-A176-568B73D7F882}"/>
              </a:ext>
            </a:extLst>
          </p:cNvPr>
          <p:cNvCxnSpPr>
            <a:cxnSpLocks/>
          </p:cNvCxnSpPr>
          <p:nvPr/>
        </p:nvCxnSpPr>
        <p:spPr>
          <a:xfrm flipH="1" flipV="1">
            <a:off x="2887436" y="5607206"/>
            <a:ext cx="474329" cy="426041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712AAFA2-EC6A-4B36-92FF-AD029AF4BE4E}"/>
              </a:ext>
            </a:extLst>
          </p:cNvPr>
          <p:cNvCxnSpPr>
            <a:cxnSpLocks/>
          </p:cNvCxnSpPr>
          <p:nvPr/>
        </p:nvCxnSpPr>
        <p:spPr>
          <a:xfrm flipV="1">
            <a:off x="2187388" y="5549950"/>
            <a:ext cx="97294" cy="57256"/>
          </a:xfrm>
          <a:prstGeom prst="straightConnector1">
            <a:avLst/>
          </a:prstGeom>
          <a:ln w="57150">
            <a:solidFill>
              <a:schemeClr val="bg1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17B7A25E-4713-4E94-8B90-2B2D19C00036}"/>
              </a:ext>
            </a:extLst>
          </p:cNvPr>
          <p:cNvCxnSpPr>
            <a:cxnSpLocks/>
          </p:cNvCxnSpPr>
          <p:nvPr/>
        </p:nvCxnSpPr>
        <p:spPr>
          <a:xfrm flipH="1" flipV="1">
            <a:off x="2580517" y="5015536"/>
            <a:ext cx="99930" cy="130005"/>
          </a:xfrm>
          <a:prstGeom prst="straightConnector1">
            <a:avLst/>
          </a:prstGeom>
          <a:ln w="57150">
            <a:solidFill>
              <a:schemeClr val="bg1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065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BAFADBE-F65C-4998-B7CD-1DADA2ADADB3}"/>
              </a:ext>
            </a:extLst>
          </p:cNvPr>
          <p:cNvSpPr/>
          <p:nvPr/>
        </p:nvSpPr>
        <p:spPr>
          <a:xfrm>
            <a:off x="411892" y="59967"/>
            <a:ext cx="11368216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3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 representative false-positive case of the pre-defined MRI system</a:t>
            </a:r>
            <a:r>
              <a:rPr lang="ja-JP" altLang="en-US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ellular leiomyoma). Low signal intensity (SI) rim (A, long arrow) and intra-tumoral bands (A, arrowheads) were observed on T2-weighted images. Speckled appearance (diffusely scattered T2 high SI within tumor, short arrows) was also observed, which might indicate leiomyoma. The tumor showed high SI on diffusion-weighted images (B)</a:t>
            </a:r>
            <a:r>
              <a:rPr lang="ja-JP" altLang="en-US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ith</a:t>
            </a:r>
            <a:r>
              <a:rPr lang="ja-JP" altLang="en-US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elatively low</a:t>
            </a:r>
            <a:r>
              <a:rPr lang="ja-JP" altLang="en-US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pparent diffusion coefficient (C). </a:t>
            </a:r>
            <a:endParaRPr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DA3A551-63E0-42B5-9A05-D75433236FD1}"/>
              </a:ext>
            </a:extLst>
          </p:cNvPr>
          <p:cNvSpPr txBox="1"/>
          <p:nvPr/>
        </p:nvSpPr>
        <p:spPr>
          <a:xfrm>
            <a:off x="241872" y="2521891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D623B4A-B984-4228-ACCF-A2C132B3845D}"/>
              </a:ext>
            </a:extLst>
          </p:cNvPr>
          <p:cNvSpPr txBox="1"/>
          <p:nvPr/>
        </p:nvSpPr>
        <p:spPr>
          <a:xfrm>
            <a:off x="3859940" y="2521891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83685D-8C3F-4DF8-8EA1-CE0B33F8614D}"/>
              </a:ext>
            </a:extLst>
          </p:cNvPr>
          <p:cNvSpPr txBox="1"/>
          <p:nvPr/>
        </p:nvSpPr>
        <p:spPr>
          <a:xfrm>
            <a:off x="8042077" y="2521891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5C60A8AB-914C-4F1D-89D6-2C80060969B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408" t="4862" r="18551" b="15499"/>
          <a:stretch/>
        </p:blipFill>
        <p:spPr>
          <a:xfrm>
            <a:off x="8042077" y="3045180"/>
            <a:ext cx="4099030" cy="327572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94D78009-E825-4B47-B105-D627D8BFCB7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8598" t="7763" r="19153" b="10582"/>
          <a:stretch/>
        </p:blipFill>
        <p:spPr>
          <a:xfrm>
            <a:off x="3836532" y="3045179"/>
            <a:ext cx="4099032" cy="3275721"/>
          </a:xfrm>
          <a:prstGeom prst="rect">
            <a:avLst/>
          </a:prstGeom>
        </p:spPr>
      </p:pic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F8631C69-B1D0-49A3-A8E4-0D83450D7B65}"/>
              </a:ext>
            </a:extLst>
          </p:cNvPr>
          <p:cNvGrpSpPr/>
          <p:nvPr/>
        </p:nvGrpSpPr>
        <p:grpSpPr>
          <a:xfrm>
            <a:off x="216488" y="2891223"/>
            <a:ext cx="3496765" cy="3958799"/>
            <a:chOff x="352025" y="2789756"/>
            <a:chExt cx="3496765" cy="3958799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949CBFEF-4F91-40A9-8523-3D75E19C43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0980" t="11092" r="24854" b="17220"/>
            <a:stretch/>
          </p:blipFill>
          <p:spPr>
            <a:xfrm>
              <a:off x="352025" y="2789756"/>
              <a:ext cx="3496765" cy="3958799"/>
            </a:xfrm>
            <a:prstGeom prst="rect">
              <a:avLst/>
            </a:prstGeom>
          </p:spPr>
        </p:pic>
        <p:cxnSp>
          <p:nvCxnSpPr>
            <p:cNvPr id="13" name="直線矢印コネクタ 12">
              <a:extLst>
                <a:ext uri="{FF2B5EF4-FFF2-40B4-BE49-F238E27FC236}">
                  <a16:creationId xmlns:a16="http://schemas.microsoft.com/office/drawing/2014/main" id="{AADD4355-1471-49F3-BB02-EB33AB030A0B}"/>
                </a:ext>
              </a:extLst>
            </p:cNvPr>
            <p:cNvCxnSpPr>
              <a:cxnSpLocks/>
            </p:cNvCxnSpPr>
            <p:nvPr/>
          </p:nvCxnSpPr>
          <p:spPr>
            <a:xfrm>
              <a:off x="1485947" y="3029644"/>
              <a:ext cx="19698" cy="773012"/>
            </a:xfrm>
            <a:prstGeom prst="straightConnector1">
              <a:avLst/>
            </a:prstGeom>
            <a:ln w="571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45629950-9D46-428B-B53B-37F6690C17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18587" y="4605819"/>
              <a:ext cx="74789" cy="52492"/>
            </a:xfrm>
            <a:prstGeom prst="straightConnector1">
              <a:avLst/>
            </a:prstGeom>
            <a:ln w="57150">
              <a:solidFill>
                <a:schemeClr val="bg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82A55C6F-CF4F-4B2C-9171-92C0A649673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66742" y="5448482"/>
              <a:ext cx="137087" cy="64551"/>
            </a:xfrm>
            <a:prstGeom prst="straightConnector1">
              <a:avLst/>
            </a:prstGeom>
            <a:ln w="57150">
              <a:solidFill>
                <a:schemeClr val="bg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59A97324-CE32-4263-AB94-224363826B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58838" y="5035622"/>
              <a:ext cx="226333" cy="210956"/>
            </a:xfrm>
            <a:prstGeom prst="straightConnector1">
              <a:avLst/>
            </a:prstGeom>
            <a:ln w="571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矢印コネクタ 18">
              <a:extLst>
                <a:ext uri="{FF2B5EF4-FFF2-40B4-BE49-F238E27FC236}">
                  <a16:creationId xmlns:a16="http://schemas.microsoft.com/office/drawing/2014/main" id="{9DF74AC7-1B96-4653-8C74-7FE4CBC820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100408" y="4658311"/>
              <a:ext cx="284763" cy="0"/>
            </a:xfrm>
            <a:prstGeom prst="straightConnector1">
              <a:avLst/>
            </a:prstGeom>
            <a:ln w="571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993316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E6D52BE0-D1F2-4D4E-9E19-67E22E1C29E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577" t="10121" r="12039" b="5748"/>
          <a:stretch/>
        </p:blipFill>
        <p:spPr>
          <a:xfrm>
            <a:off x="411892" y="3173433"/>
            <a:ext cx="3367598" cy="3622089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CBAFADBE-F65C-4998-B7CD-1DADA2ADADB3}"/>
              </a:ext>
            </a:extLst>
          </p:cNvPr>
          <p:cNvSpPr/>
          <p:nvPr/>
        </p:nvSpPr>
        <p:spPr>
          <a:xfrm>
            <a:off x="413049" y="121929"/>
            <a:ext cx="11368216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l Figure 4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r>
              <a:rPr lang="en-US" altLang="ja-JP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other false-positive case of the pre-defined MRI system (cellular leiomyoma). Nodular border (A, *), low signal intensity (SI) rim (A, long arrow) and intra-tumoral bands (A, arrowheads) were observed on T2-weighted images. Speckled appearance was recorded only by Reader 1 (A, short arrows). The tumor showed high SI on diffusion-weighted images (B). Heterogenous tumor enhancement on contrast enhanced T1-weighted images was observed (C, long arrow).  </a:t>
            </a:r>
            <a:endParaRPr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DA3A551-63E0-42B5-9A05-D75433236FD1}"/>
              </a:ext>
            </a:extLst>
          </p:cNvPr>
          <p:cNvSpPr txBox="1"/>
          <p:nvPr/>
        </p:nvSpPr>
        <p:spPr>
          <a:xfrm>
            <a:off x="365140" y="2790730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D623B4A-B984-4228-ACCF-A2C132B3845D}"/>
              </a:ext>
            </a:extLst>
          </p:cNvPr>
          <p:cNvSpPr txBox="1"/>
          <p:nvPr/>
        </p:nvSpPr>
        <p:spPr>
          <a:xfrm>
            <a:off x="4431813" y="2790730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F83685D-8C3F-4DF8-8EA1-CE0B33F8614D}"/>
              </a:ext>
            </a:extLst>
          </p:cNvPr>
          <p:cNvSpPr txBox="1"/>
          <p:nvPr/>
        </p:nvSpPr>
        <p:spPr>
          <a:xfrm>
            <a:off x="8366915" y="2790730"/>
            <a:ext cx="341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AADD4355-1471-49F3-BB02-EB33AB030A0B}"/>
              </a:ext>
            </a:extLst>
          </p:cNvPr>
          <p:cNvCxnSpPr>
            <a:cxnSpLocks/>
          </p:cNvCxnSpPr>
          <p:nvPr/>
        </p:nvCxnSpPr>
        <p:spPr>
          <a:xfrm flipV="1">
            <a:off x="1543309" y="5814220"/>
            <a:ext cx="99897" cy="559947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45629950-9D46-428B-B53B-37F6690C17CE}"/>
              </a:ext>
            </a:extLst>
          </p:cNvPr>
          <p:cNvCxnSpPr>
            <a:cxnSpLocks/>
          </p:cNvCxnSpPr>
          <p:nvPr/>
        </p:nvCxnSpPr>
        <p:spPr>
          <a:xfrm flipV="1">
            <a:off x="1705351" y="3976537"/>
            <a:ext cx="129372" cy="80559"/>
          </a:xfrm>
          <a:prstGeom prst="straightConnector1">
            <a:avLst/>
          </a:prstGeom>
          <a:ln w="57150">
            <a:solidFill>
              <a:schemeClr val="bg1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図 16">
            <a:extLst>
              <a:ext uri="{FF2B5EF4-FFF2-40B4-BE49-F238E27FC236}">
                <a16:creationId xmlns:a16="http://schemas.microsoft.com/office/drawing/2014/main" id="{D0BBA1F5-140B-413C-8AA2-576137D8810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74" t="10110" r="6496" b="4970"/>
          <a:stretch/>
        </p:blipFill>
        <p:spPr>
          <a:xfrm>
            <a:off x="8413667" y="3173433"/>
            <a:ext cx="3367598" cy="3622089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54F6F6CE-1AD4-4AB0-A6A4-FC6DBDA76C7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742" t="11122" r="12627" b="8654"/>
          <a:stretch/>
        </p:blipFill>
        <p:spPr>
          <a:xfrm>
            <a:off x="4484408" y="3173432"/>
            <a:ext cx="3367599" cy="3622090"/>
          </a:xfrm>
          <a:prstGeom prst="rect">
            <a:avLst/>
          </a:prstGeom>
        </p:spPr>
      </p:pic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55D59291-D4BA-453D-9F93-B2B1D351BDF4}"/>
              </a:ext>
            </a:extLst>
          </p:cNvPr>
          <p:cNvCxnSpPr>
            <a:cxnSpLocks/>
          </p:cNvCxnSpPr>
          <p:nvPr/>
        </p:nvCxnSpPr>
        <p:spPr>
          <a:xfrm>
            <a:off x="1633634" y="4600853"/>
            <a:ext cx="19143" cy="212226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48BAAC2D-BF44-4B9F-8FBD-D4646E322586}"/>
              </a:ext>
            </a:extLst>
          </p:cNvPr>
          <p:cNvCxnSpPr>
            <a:cxnSpLocks/>
          </p:cNvCxnSpPr>
          <p:nvPr/>
        </p:nvCxnSpPr>
        <p:spPr>
          <a:xfrm flipH="1">
            <a:off x="2231306" y="4314548"/>
            <a:ext cx="102115" cy="198169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C9DC1EEB-1039-4925-93CF-3036820F9E69}"/>
              </a:ext>
            </a:extLst>
          </p:cNvPr>
          <p:cNvSpPr txBox="1"/>
          <p:nvPr/>
        </p:nvSpPr>
        <p:spPr>
          <a:xfrm>
            <a:off x="2025689" y="3791871"/>
            <a:ext cx="51395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400" dirty="0">
                <a:solidFill>
                  <a:schemeClr val="bg1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</a:t>
            </a:r>
            <a:endParaRPr lang="ja-JP" altLang="en-US" sz="2400" dirty="0">
              <a:solidFill>
                <a:schemeClr val="bg1"/>
              </a:solidFill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74F93A35-D12A-432D-9043-7F1EB1DD9A49}"/>
              </a:ext>
            </a:extLst>
          </p:cNvPr>
          <p:cNvCxnSpPr>
            <a:cxnSpLocks/>
          </p:cNvCxnSpPr>
          <p:nvPr/>
        </p:nvCxnSpPr>
        <p:spPr>
          <a:xfrm flipH="1" flipV="1">
            <a:off x="9865408" y="5087732"/>
            <a:ext cx="129442" cy="522956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5590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4</TotalTime>
  <Words>414</Words>
  <Application>Microsoft Office PowerPoint</Application>
  <PresentationFormat>ワイド画面</PresentationFormat>
  <Paragraphs>41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Century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祐紀 樋本</dc:creator>
  <cp:lastModifiedBy>祐紀 樋本</cp:lastModifiedBy>
  <cp:revision>35</cp:revision>
  <dcterms:created xsi:type="dcterms:W3CDTF">2020-05-27T06:32:35Z</dcterms:created>
  <dcterms:modified xsi:type="dcterms:W3CDTF">2021-02-20T13:09:23Z</dcterms:modified>
</cp:coreProperties>
</file>